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259079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34148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29549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389252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23638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364213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241419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216341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965958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39383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35435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A2C55-DF05-4890-94DB-659390C9BF64}" type="datetimeFigureOut">
              <a:rPr kumimoji="1" lang="ja-JP" altLang="en-US" smtClean="0"/>
              <a:pPr/>
              <a:t>2016/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2E594-B8B7-425A-A240-353CF4B43E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49201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915816" y="1373945"/>
            <a:ext cx="5252114" cy="41459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3688185" y="5589240"/>
            <a:ext cx="4248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   male                                              female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547664" y="696947"/>
            <a:ext cx="31363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Change in arterial pulse amplitude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23528" y="116632"/>
            <a:ext cx="4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ure </a:t>
            </a:r>
            <a:r>
              <a:rPr kumimoji="1" lang="en-US" altLang="ja-JP" dirty="0" err="1" smtClean="0"/>
              <a:t>S1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23528" y="6093296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The difference </a:t>
            </a:r>
            <a:r>
              <a:rPr lang="en-US" altLang="ja-JP" dirty="0" smtClean="0"/>
              <a:t>of</a:t>
            </a:r>
            <a:r>
              <a:rPr kumimoji="1" lang="en-US" altLang="ja-JP" dirty="0" smtClean="0"/>
              <a:t> the change in arterial pulse amplitude was not significant between subjects with male and female.</a:t>
            </a:r>
            <a:endParaRPr kumimoji="1" lang="ja-JP" altLang="en-US" dirty="0"/>
          </a:p>
        </p:txBody>
      </p:sp>
      <p:cxnSp>
        <p:nvCxnSpPr>
          <p:cNvPr id="8" name="直線コネクタ 7"/>
          <p:cNvCxnSpPr/>
          <p:nvPr/>
        </p:nvCxnSpPr>
        <p:spPr>
          <a:xfrm>
            <a:off x="4355976" y="1048299"/>
            <a:ext cx="0" cy="3600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6986877" y="1048299"/>
            <a:ext cx="0" cy="3600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4355976" y="1048299"/>
            <a:ext cx="26309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5186677" y="625543"/>
            <a:ext cx="13321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N.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xmlns="" val="30522984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707904" y="5723964"/>
            <a:ext cx="4464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HT (-)                                             HT (+)</a:t>
            </a:r>
            <a:endParaRPr kumimoji="1" lang="ja-JP" altLang="en-US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490180" y="1093437"/>
            <a:ext cx="5560299" cy="4503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866197" y="764704"/>
            <a:ext cx="32351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Change in arterial pulse amplitude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23528" y="6093296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The difference </a:t>
            </a:r>
            <a:r>
              <a:rPr lang="en-US" altLang="ja-JP" dirty="0" smtClean="0"/>
              <a:t>of</a:t>
            </a:r>
            <a:r>
              <a:rPr kumimoji="1" lang="en-US" altLang="ja-JP" dirty="0" smtClean="0"/>
              <a:t> the change in arterial pulse amplitude was not significant between subjects with and without hypertension (HT).</a:t>
            </a:r>
            <a:endParaRPr kumimoji="1" lang="ja-JP" altLang="en-US" dirty="0"/>
          </a:p>
        </p:txBody>
      </p:sp>
      <p:cxnSp>
        <p:nvCxnSpPr>
          <p:cNvPr id="6" name="直線コネクタ 5"/>
          <p:cNvCxnSpPr/>
          <p:nvPr/>
        </p:nvCxnSpPr>
        <p:spPr>
          <a:xfrm>
            <a:off x="4101339" y="908720"/>
            <a:ext cx="0" cy="3600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6732240" y="908720"/>
            <a:ext cx="0" cy="3600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4101339" y="908720"/>
            <a:ext cx="26309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323528" y="116632"/>
            <a:ext cx="4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ure </a:t>
            </a:r>
            <a:r>
              <a:rPr kumimoji="1" lang="en-US" altLang="ja-JP" dirty="0" err="1" smtClean="0"/>
              <a:t>S2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932040" y="485964"/>
            <a:ext cx="13321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N.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xmlns="" val="1013637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63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​​テーマ</vt:lpstr>
      <vt:lpstr>Slide 1</vt:lpstr>
      <vt:lpstr>Slide 2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a</dc:creator>
  <cp:lastModifiedBy>0005155</cp:lastModifiedBy>
  <cp:revision>8</cp:revision>
  <dcterms:created xsi:type="dcterms:W3CDTF">2016-06-24T16:19:49Z</dcterms:created>
  <dcterms:modified xsi:type="dcterms:W3CDTF">2016-07-11T02:12:15Z</dcterms:modified>
</cp:coreProperties>
</file>